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0494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339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25146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5839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4544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9181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16700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8945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7128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7572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462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3E37F-C889-4D5D-BBAB-8DFC6669A74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D9D21-1C18-40E3-95A2-5C3529FF3D5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6992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3.jpe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6465" y="389680"/>
            <a:ext cx="8784976" cy="4424935"/>
            <a:chOff x="297402" y="-3062"/>
            <a:chExt cx="8784976" cy="4424935"/>
          </a:xfrm>
        </p:grpSpPr>
        <p:grpSp>
          <p:nvGrpSpPr>
            <p:cNvPr id="5" name="Group 4"/>
            <p:cNvGrpSpPr/>
            <p:nvPr/>
          </p:nvGrpSpPr>
          <p:grpSpPr>
            <a:xfrm>
              <a:off x="323528" y="653739"/>
              <a:ext cx="8634318" cy="3768134"/>
              <a:chOff x="323528" y="653739"/>
              <a:chExt cx="8634318" cy="3768134"/>
            </a:xfrm>
          </p:grpSpPr>
          <p:grpSp>
            <p:nvGrpSpPr>
              <p:cNvPr id="47" name="Group 46"/>
              <p:cNvGrpSpPr/>
              <p:nvPr/>
            </p:nvGrpSpPr>
            <p:grpSpPr>
              <a:xfrm>
                <a:off x="323528" y="653739"/>
                <a:ext cx="8634318" cy="3768134"/>
                <a:chOff x="262740" y="1480014"/>
                <a:chExt cx="8634318" cy="3768134"/>
              </a:xfrm>
            </p:grpSpPr>
            <p:pic>
              <p:nvPicPr>
                <p:cNvPr id="56" name="Picture 2" descr="D:\Running\peanut\Peanut thesis\Raw Data\VIVEK Quantity one\ASR EMSA\ASR EMSA\14.3.15\GEL 1-1.jp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21" t="3655" r="75370" b="8236"/>
                <a:stretch/>
              </p:blipFill>
              <p:spPr bwMode="auto">
                <a:xfrm>
                  <a:off x="262740" y="1480014"/>
                  <a:ext cx="1032388" cy="376813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7" name="Picture 3" descr="D:\Running\peanut\Peanut thesis\Raw Data\VIVEK Quantity one\ASR EMSA\ASR EMSA\14.3.15\GEL 1-1.jpg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368" t="3655" r="58108" b="8236"/>
                <a:stretch/>
              </p:blipFill>
              <p:spPr bwMode="auto">
                <a:xfrm>
                  <a:off x="1341562" y="1480014"/>
                  <a:ext cx="988142" cy="376813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8" name="Picture 4" descr="D:\Running\peanut\Peanut thesis\Raw Data\VIVEK Quantity one\ASR EMSA\ASR EMSA\14.3.15\GEL 1-1.jpg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630" t="3655" r="39800" b="8236"/>
                <a:stretch/>
              </p:blipFill>
              <p:spPr bwMode="auto">
                <a:xfrm>
                  <a:off x="2365200" y="1480014"/>
                  <a:ext cx="1047135" cy="376813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9" name="Picture 6" descr="D:\Running\peanut\Peanut thesis\Raw Data\VIVEK Quantity one\ASR EMSA\ASR EMSA\14.3.15\GEL 1-2.jpg"/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846" t="3655" r="23502" b="8236"/>
                <a:stretch/>
              </p:blipFill>
              <p:spPr bwMode="auto">
                <a:xfrm>
                  <a:off x="3468671" y="1480015"/>
                  <a:ext cx="1051734" cy="376813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0" name="Picture 7" descr="D:\Running\peanut\Peanut thesis\Raw Data\VIVEK Quantity one\ASR EMSA\ASR EMSA\14.3.15\GEL 1-2.jpg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109" t="3655" r="5046" b="8237"/>
                <a:stretch/>
              </p:blipFill>
              <p:spPr bwMode="auto">
                <a:xfrm>
                  <a:off x="4568640" y="1480015"/>
                  <a:ext cx="1118976" cy="376813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1" name="Picture 8" descr="D:\Running\peanut\Peanut thesis\Raw Data\VIVEK Quantity one\ASR EMSA\ASR EMSA\14.3.15\GEL 2-1.jpg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94" t="3655" r="77355" b="8237"/>
                <a:stretch/>
              </p:blipFill>
              <p:spPr bwMode="auto">
                <a:xfrm>
                  <a:off x="5722776" y="1480014"/>
                  <a:ext cx="1080120" cy="376813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2" name="Picture 9" descr="D:\Running\peanut\Peanut thesis\Raw Data\VIVEK Quantity one\ASR EMSA\ASR EMSA\14.3.15\GEL 2-1.jpg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645" t="3655" r="61191" b="8237"/>
                <a:stretch/>
              </p:blipFill>
              <p:spPr bwMode="auto">
                <a:xfrm>
                  <a:off x="6851464" y="1480014"/>
                  <a:ext cx="936104" cy="376813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3" name="Picture 2" descr="F:\ASR EMSA\admin 2014-08-19 05hr 55min-4.jpg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50000"/>
                          </a14:imgEffect>
                          <a14:imgEffect>
                            <a14:brightnessContrast bright="24000" contrast="9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512" t="7072" r="28832" b="9627"/>
                <a:stretch/>
              </p:blipFill>
              <p:spPr bwMode="auto">
                <a:xfrm>
                  <a:off x="7829432" y="1480014"/>
                  <a:ext cx="1067626" cy="376813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cxnSp>
            <p:nvCxnSpPr>
              <p:cNvPr id="48" name="Straight Arrow Connector 47"/>
              <p:cNvCxnSpPr/>
              <p:nvPr/>
            </p:nvCxnSpPr>
            <p:spPr>
              <a:xfrm flipV="1">
                <a:off x="1043608" y="980728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2145496" y="980728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3079928" y="1092936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4139952" y="1092936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5230120" y="1100077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6516216" y="1052736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/>
              <p:cNvCxnSpPr/>
              <p:nvPr/>
            </p:nvCxnSpPr>
            <p:spPr>
              <a:xfrm flipV="1">
                <a:off x="7534376" y="970680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Arrow Connector 54"/>
              <p:cNvCxnSpPr/>
              <p:nvPr/>
            </p:nvCxnSpPr>
            <p:spPr>
              <a:xfrm flipV="1">
                <a:off x="8480528" y="917096"/>
                <a:ext cx="72008" cy="216024"/>
              </a:xfrm>
              <a:prstGeom prst="straightConnector1">
                <a:avLst/>
              </a:prstGeom>
              <a:ln w="28575">
                <a:solidFill>
                  <a:srgbClr val="00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/>
            <p:cNvGrpSpPr/>
            <p:nvPr/>
          </p:nvGrpSpPr>
          <p:grpSpPr>
            <a:xfrm>
              <a:off x="297402" y="-3062"/>
              <a:ext cx="8784976" cy="696854"/>
              <a:chOff x="297402" y="-3062"/>
              <a:chExt cx="8784976" cy="696854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6810295" y="-3057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43" name="Straight Connector 42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TextBox 43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7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7883230" y="-835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39" name="Straight Connector 38"/>
                <p:cNvCxnSpPr/>
                <p:nvPr/>
              </p:nvCxnSpPr>
              <p:spPr>
                <a:xfrm>
                  <a:off x="349654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8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5734773" y="5650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35" name="Straight Connector 34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TextBox 35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6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4592079" y="5650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31" name="Straight Connector 30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TextBox 31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5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3479140" y="5650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27" name="Straight Connector 26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4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2411760" y="5650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23" name="Straight Connector 22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TextBox 23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3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1325270" y="1294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19" name="Straight Connector 18"/>
                <p:cNvCxnSpPr/>
                <p:nvPr/>
              </p:nvCxnSpPr>
              <p:spPr>
                <a:xfrm>
                  <a:off x="362717" y="260648"/>
                  <a:ext cx="972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2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297402" y="-3062"/>
                <a:ext cx="1199148" cy="688142"/>
                <a:chOff x="303081" y="-27384"/>
                <a:chExt cx="1199148" cy="688142"/>
              </a:xfrm>
            </p:grpSpPr>
            <p:cxnSp>
              <p:nvCxnSpPr>
                <p:cNvPr id="15" name="Straight Connector 14"/>
                <p:cNvCxnSpPr/>
                <p:nvPr/>
              </p:nvCxnSpPr>
              <p:spPr>
                <a:xfrm>
                  <a:off x="336591" y="260648"/>
                  <a:ext cx="1008000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extBox 15"/>
                <p:cNvSpPr txBox="1"/>
                <p:nvPr/>
              </p:nvSpPr>
              <p:spPr>
                <a:xfrm>
                  <a:off x="303081" y="260648"/>
                  <a:ext cx="5245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807137" y="260648"/>
                  <a:ext cx="69509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Probe + Protein</a:t>
                  </a:r>
                  <a:endParaRPr lang="en-IN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441418" y="-27384"/>
                  <a:ext cx="9236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smtClean="0">
                      <a:latin typeface="Arial" pitchFamily="34" charset="0"/>
                      <a:cs typeface="Arial" pitchFamily="34" charset="0"/>
                    </a:rPr>
                    <a:t>ARBS-1</a:t>
                  </a:r>
                  <a:endParaRPr lang="en-IN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sp>
        <p:nvSpPr>
          <p:cNvPr id="65" name="TextBox 64"/>
          <p:cNvSpPr txBox="1"/>
          <p:nvPr/>
        </p:nvSpPr>
        <p:spPr>
          <a:xfrm>
            <a:off x="122758" y="4941168"/>
            <a:ext cx="871415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6:</a:t>
            </a:r>
            <a:r>
              <a:rPr lang="en-US" sz="140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creening of all eight probes for determining the exact binding site for </a:t>
            </a:r>
            <a:r>
              <a:rPr lang="en-US" sz="14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sz="14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SR-1 protein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ll probes ARSB-1 and ARBS-8 showed clear shifting of band (denoted with blue arrow) which was absent in the lane containing only probe.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954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4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5</cp:revision>
  <dcterms:created xsi:type="dcterms:W3CDTF">2015-04-15T03:04:10Z</dcterms:created>
  <dcterms:modified xsi:type="dcterms:W3CDTF">2015-04-27T06:24:44Z</dcterms:modified>
</cp:coreProperties>
</file>